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71" autoAdjust="0"/>
    <p:restoredTop sz="94660"/>
  </p:normalViewPr>
  <p:slideViewPr>
    <p:cSldViewPr snapToGrid="0">
      <p:cViewPr varScale="1">
        <p:scale>
          <a:sx n="54" d="100"/>
          <a:sy n="54" d="100"/>
        </p:scale>
        <p:origin x="19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76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23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543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801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283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039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41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812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9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607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266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62A9E-604A-4A2C-8CE8-5A1A6C8D2144}" type="datetimeFigureOut">
              <a:rPr kumimoji="1" lang="ja-JP" altLang="en-US" smtClean="0"/>
              <a:t>2020/1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9436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394446" y="268941"/>
            <a:ext cx="6113930" cy="28328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b="1" dirty="0">
                <a:solidFill>
                  <a:schemeClr val="tx1"/>
                </a:solidFill>
              </a:rPr>
              <a:t>Figure 7. </a:t>
            </a:r>
            <a:r>
              <a:rPr lang="en-US" altLang="ja-JP" dirty="0">
                <a:solidFill>
                  <a:schemeClr val="tx1"/>
                </a:solidFill>
              </a:rPr>
              <a:t>Effect of cardiac GPR14 expression on DS37001789 and plasma concentrations of DS37001789 after 4 weeks of administration in pressure-overload mice. </a:t>
            </a:r>
            <a:endParaRPr lang="ja-JP" altLang="ja-JP" dirty="0">
              <a:solidFill>
                <a:schemeClr val="tx1"/>
              </a:solidFill>
            </a:endParaRPr>
          </a:p>
          <a:p>
            <a:r>
              <a:rPr lang="en-US" altLang="ja-JP" dirty="0">
                <a:solidFill>
                  <a:schemeClr val="tx1"/>
                </a:solidFill>
              </a:rPr>
              <a:t>(A) GPR14 expression in left ventricle by western blot analysis. GPR14 expression levels normalized to GAPDH levels in vehicle-treated sham-operated mice (Sham, n=3), vehicle-treated transverse aortic constriction-induced pressure-overload mice (TAC) (Vehicle, n=4), and 0.2% DS37001789-treated TAC mice (n=3) were measured. 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2246" y="3101789"/>
            <a:ext cx="4267936" cy="2395568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2246" y="5771490"/>
            <a:ext cx="4270314" cy="2870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27449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.pptx" id="{1E39CEC3-E423-4FB3-BDE8-ECFA3A5FB86C}" vid="{AA5D0353-88DC-447E-A034-4D9D51FBF58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5292</TotalTime>
  <Words>79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DAIICHI SANKYO CO.,LTD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SHI MINA / 西 美奈</dc:creator>
  <cp:lastModifiedBy>NISHI MINA / 西 美奈</cp:lastModifiedBy>
  <cp:revision>99</cp:revision>
  <cp:lastPrinted>2019-04-26T09:07:51Z</cp:lastPrinted>
  <dcterms:created xsi:type="dcterms:W3CDTF">2018-05-08T23:00:01Z</dcterms:created>
  <dcterms:modified xsi:type="dcterms:W3CDTF">2020-01-27T01:50:32Z</dcterms:modified>
</cp:coreProperties>
</file>